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2913" cy="9918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1511BB-C2AE-4062-8DDD-4F6C6803B30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9207F3-B5B7-46E9-87E7-EEADBA8E5A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63E543-73A0-4F5A-AB93-D60935A3CA1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C35CC8-2446-4F1B-9C0D-AA3BB305183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B011DF-8474-40A0-8932-2FDACCBDE9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ACBE95-2938-43F1-AC82-9352A20A88D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998C83-1391-4F5D-82BB-5C668ECF77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F12642-A510-44D1-A213-E834ADF7D7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7D0D8E-1683-4FB1-B7C8-6C30C4B44C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3676DA-A0E1-48FD-B5E3-94B101B536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FE8858-CCA4-4DCE-B2FA-31E5AF46DD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C86396-5A5E-4744-9D13-20356D14E3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0034D6E-43F3-43BB-BA05-68FB9E3DACBB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778"/>
          <p:cNvSpPr/>
          <p:nvPr/>
        </p:nvSpPr>
        <p:spPr>
          <a:xfrm>
            <a:off x="7220520" y="0"/>
            <a:ext cx="1917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cc"/>
                </a:solidFill>
                <a:latin typeface="Arial Narrow"/>
                <a:ea typeface="Vrinda"/>
              </a:rPr>
              <a:t>Figure S5. Yun </a:t>
            </a:r>
            <a:r>
              <a:rPr b="0" i="1" lang="en-US" sz="1400" spc="-1" strike="noStrike">
                <a:solidFill>
                  <a:srgbClr val="0000cc"/>
                </a:solidFill>
                <a:latin typeface="Arial Narrow"/>
                <a:ea typeface="Vrinda"/>
              </a:rPr>
              <a:t>et al</a:t>
            </a:r>
            <a:r>
              <a:rPr b="0" lang="en-US" sz="1400" spc="-1" strike="noStrike">
                <a:solidFill>
                  <a:srgbClr val="0000cc"/>
                </a:solidFill>
                <a:latin typeface="Arial Narrow"/>
                <a:ea typeface="Vrinda"/>
              </a:rPr>
              <a:t>., 2014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grpSp>
        <p:nvGrpSpPr>
          <p:cNvPr id="42" name="Group 29"/>
          <p:cNvGrpSpPr/>
          <p:nvPr/>
        </p:nvGrpSpPr>
        <p:grpSpPr>
          <a:xfrm>
            <a:off x="2352240" y="1359720"/>
            <a:ext cx="4280040" cy="3402360"/>
            <a:chOff x="2352240" y="1359720"/>
            <a:chExt cx="4280040" cy="3402360"/>
          </a:xfrm>
        </p:grpSpPr>
        <p:grpSp>
          <p:nvGrpSpPr>
            <p:cNvPr id="43" name="Group 19"/>
            <p:cNvGrpSpPr/>
            <p:nvPr/>
          </p:nvGrpSpPr>
          <p:grpSpPr>
            <a:xfrm>
              <a:off x="3479760" y="3194640"/>
              <a:ext cx="2592360" cy="291240"/>
              <a:chOff x="3479760" y="3194640"/>
              <a:chExt cx="2592360" cy="291240"/>
            </a:xfrm>
          </p:grpSpPr>
          <p:grpSp>
            <p:nvGrpSpPr>
              <p:cNvPr id="44" name="Group 13"/>
              <p:cNvGrpSpPr/>
              <p:nvPr/>
            </p:nvGrpSpPr>
            <p:grpSpPr>
              <a:xfrm>
                <a:off x="3479760" y="3195000"/>
                <a:ext cx="2591640" cy="290520"/>
                <a:chOff x="3479760" y="3195000"/>
                <a:chExt cx="2591640" cy="290520"/>
              </a:xfrm>
            </p:grpSpPr>
            <p:pic>
              <p:nvPicPr>
                <p:cNvPr id="45" name="Picture 17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4630680" y="3195000"/>
                  <a:ext cx="1135080" cy="2905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6" name="Picture 16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3479760" y="3195000"/>
                  <a:ext cx="1151640" cy="2905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7" name="Picture 18" descr=""/>
                <p:cNvPicPr/>
                <p:nvPr/>
              </p:nvPicPr>
              <p:blipFill>
                <a:blip r:embed="rId3"/>
                <a:srcRect l="0" t="0" r="13191" b="0"/>
                <a:stretch/>
              </p:blipFill>
              <p:spPr>
                <a:xfrm>
                  <a:off x="5763240" y="3195000"/>
                  <a:ext cx="308160" cy="29052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48" name="직사각형 399"/>
              <p:cNvSpPr/>
              <p:nvPr/>
            </p:nvSpPr>
            <p:spPr>
              <a:xfrm>
                <a:off x="3479760" y="3194640"/>
                <a:ext cx="2592360" cy="291240"/>
              </a:xfrm>
              <a:prstGeom prst="rect">
                <a:avLst/>
              </a:pr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49" name="Group 26"/>
            <p:cNvGrpSpPr/>
            <p:nvPr/>
          </p:nvGrpSpPr>
          <p:grpSpPr>
            <a:xfrm>
              <a:off x="3349800" y="1359720"/>
              <a:ext cx="2948400" cy="1288800"/>
              <a:chOff x="3349800" y="1359720"/>
              <a:chExt cx="2948400" cy="1288800"/>
            </a:xfrm>
          </p:grpSpPr>
          <p:sp>
            <p:nvSpPr>
              <p:cNvPr id="50" name="Rectangle 766"/>
              <p:cNvSpPr/>
              <p:nvPr/>
            </p:nvSpPr>
            <p:spPr>
              <a:xfrm rot="18360000">
                <a:off x="3362760" y="2227680"/>
                <a:ext cx="4795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Mock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1" name="Rectangle 766"/>
              <p:cNvSpPr/>
              <p:nvPr/>
            </p:nvSpPr>
            <p:spPr>
              <a:xfrm rot="18360000">
                <a:off x="3362760" y="1856520"/>
                <a:ext cx="1369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SA</a:t>
                </a:r>
                <a:r>
                  <a:rPr b="0" lang="en-US" sz="1200" spc="-1" strike="noStrike" baseline="-5000">
                    <a:solidFill>
                      <a:srgbClr val="000000"/>
                    </a:solidFill>
                    <a:latin typeface="Arial Narrow"/>
                    <a:ea typeface="Arial"/>
                  </a:rPr>
                  <a:t>14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-14-2</a:t>
                </a:r>
                <a:r>
                  <a:rPr b="0" lang="en-US" sz="1200" spc="-1" strike="noStrike" baseline="25000">
                    <a:solidFill>
                      <a:srgbClr val="000000"/>
                    </a:solidFill>
                    <a:latin typeface="Arial Narrow"/>
                    <a:ea typeface="Arial"/>
                  </a:rPr>
                  <a:t>MCV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 (Parent)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2" name="Rectangle 766"/>
              <p:cNvSpPr/>
              <p:nvPr/>
            </p:nvSpPr>
            <p:spPr>
              <a:xfrm rot="18360000">
                <a:off x="3874320" y="2231280"/>
                <a:ext cx="487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G</a:t>
                </a:r>
                <a:r>
                  <a:rPr b="0" lang="en-US" sz="1200" spc="-1" strike="noStrike" baseline="30000">
                    <a:solidFill>
                      <a:srgbClr val="000000"/>
                    </a:solidFill>
                    <a:latin typeface="Arial Narrow"/>
                    <a:ea typeface="Arial"/>
                  </a:rPr>
                  <a:t>244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D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3" name="Rectangle 766"/>
              <p:cNvSpPr/>
              <p:nvPr/>
            </p:nvSpPr>
            <p:spPr>
              <a:xfrm rot="18360000">
                <a:off x="4034880" y="2231280"/>
                <a:ext cx="487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G</a:t>
                </a:r>
                <a:r>
                  <a:rPr b="0" lang="en-US" sz="1200" spc="-1" strike="noStrike" baseline="30000">
                    <a:solidFill>
                      <a:srgbClr val="000000"/>
                    </a:solidFill>
                    <a:latin typeface="Arial Narrow"/>
                    <a:ea typeface="Arial"/>
                  </a:rPr>
                  <a:t>244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R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4" name="Rectangle 766"/>
              <p:cNvSpPr/>
              <p:nvPr/>
            </p:nvSpPr>
            <p:spPr>
              <a:xfrm rot="18360000">
                <a:off x="4199040" y="2233800"/>
                <a:ext cx="48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G</a:t>
                </a:r>
                <a:r>
                  <a:rPr b="0" lang="en-US" sz="1200" spc="-1" strike="noStrike" baseline="30000">
                    <a:solidFill>
                      <a:srgbClr val="000000"/>
                    </a:solidFill>
                    <a:latin typeface="Arial Narrow"/>
                    <a:ea typeface="Arial"/>
                  </a:rPr>
                  <a:t>244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K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5" name="Rectangle 766"/>
              <p:cNvSpPr/>
              <p:nvPr/>
            </p:nvSpPr>
            <p:spPr>
              <a:xfrm rot="18360000">
                <a:off x="4363200" y="2237400"/>
                <a:ext cx="4734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G</a:t>
                </a:r>
                <a:r>
                  <a:rPr b="0" lang="en-US" sz="1200" spc="-1" strike="noStrike" baseline="30000">
                    <a:solidFill>
                      <a:srgbClr val="000000"/>
                    </a:solidFill>
                    <a:latin typeface="Arial Narrow"/>
                    <a:ea typeface="Arial"/>
                  </a:rPr>
                  <a:t>244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F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6" name="Rectangle 766"/>
              <p:cNvSpPr/>
              <p:nvPr/>
            </p:nvSpPr>
            <p:spPr>
              <a:xfrm rot="18360000">
                <a:off x="4503240" y="2220480"/>
                <a:ext cx="514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G</a:t>
                </a:r>
                <a:r>
                  <a:rPr b="0" lang="en-US" sz="1200" spc="-1" strike="noStrike" baseline="30000">
                    <a:solidFill>
                      <a:srgbClr val="000000"/>
                    </a:solidFill>
                    <a:latin typeface="Arial Narrow"/>
                    <a:ea typeface="Arial"/>
                  </a:rPr>
                  <a:t>244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W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7" name="Rectangle 766"/>
              <p:cNvSpPr/>
              <p:nvPr/>
            </p:nvSpPr>
            <p:spPr>
              <a:xfrm rot="18360000">
                <a:off x="3717360" y="2233800"/>
                <a:ext cx="48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G</a:t>
                </a:r>
                <a:r>
                  <a:rPr b="0" lang="en-US" sz="1200" spc="-1" strike="noStrike" baseline="30000">
                    <a:solidFill>
                      <a:srgbClr val="000000"/>
                    </a:solidFill>
                    <a:latin typeface="Arial Narrow"/>
                    <a:ea typeface="Arial"/>
                  </a:rPr>
                  <a:t>244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E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8" name="Rectangle 766"/>
              <p:cNvSpPr/>
              <p:nvPr/>
            </p:nvSpPr>
            <p:spPr>
              <a:xfrm rot="18360000">
                <a:off x="5643720" y="2233800"/>
                <a:ext cx="48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G</a:t>
                </a:r>
                <a:r>
                  <a:rPr b="0" lang="en-US" sz="1200" spc="-1" strike="noStrike" baseline="30000">
                    <a:solidFill>
                      <a:srgbClr val="000000"/>
                    </a:solidFill>
                    <a:latin typeface="Arial Narrow"/>
                    <a:ea typeface="Arial"/>
                  </a:rPr>
                  <a:t>244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A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9" name="Rectangle 766"/>
              <p:cNvSpPr/>
              <p:nvPr/>
            </p:nvSpPr>
            <p:spPr>
              <a:xfrm rot="18360000">
                <a:off x="5329440" y="2239920"/>
                <a:ext cx="467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G</a:t>
                </a:r>
                <a:r>
                  <a:rPr b="0" lang="en-US" sz="1200" spc="-1" strike="noStrike" baseline="30000">
                    <a:solidFill>
                      <a:srgbClr val="000000"/>
                    </a:solidFill>
                    <a:latin typeface="Arial Narrow"/>
                    <a:ea typeface="Arial"/>
                  </a:rPr>
                  <a:t>244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L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0" name="Rectangle 766"/>
              <p:cNvSpPr/>
              <p:nvPr/>
            </p:nvSpPr>
            <p:spPr>
              <a:xfrm rot="18360000">
                <a:off x="5483160" y="2233800"/>
                <a:ext cx="48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G</a:t>
                </a:r>
                <a:r>
                  <a:rPr b="0" lang="en-US" sz="1200" spc="-1" strike="noStrike" baseline="30000">
                    <a:solidFill>
                      <a:srgbClr val="000000"/>
                    </a:solidFill>
                    <a:latin typeface="Arial Narrow"/>
                    <a:ea typeface="Arial"/>
                  </a:rPr>
                  <a:t>244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P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1" name="Rectangle 766"/>
              <p:cNvSpPr/>
              <p:nvPr/>
            </p:nvSpPr>
            <p:spPr>
              <a:xfrm rot="18360000">
                <a:off x="5804280" y="2233800"/>
                <a:ext cx="48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G</a:t>
                </a:r>
                <a:r>
                  <a:rPr b="0" lang="en-US" sz="1200" spc="-1" strike="noStrike" baseline="30000">
                    <a:solidFill>
                      <a:srgbClr val="000000"/>
                    </a:solidFill>
                    <a:latin typeface="Arial Narrow"/>
                    <a:ea typeface="Arial"/>
                  </a:rPr>
                  <a:t>244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V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2" name="Rectangle 766"/>
              <p:cNvSpPr/>
              <p:nvPr/>
            </p:nvSpPr>
            <p:spPr>
              <a:xfrm rot="18360000">
                <a:off x="4841280" y="2233800"/>
                <a:ext cx="48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G</a:t>
                </a:r>
                <a:r>
                  <a:rPr b="0" lang="en-US" sz="1200" spc="-1" strike="noStrike" baseline="30000">
                    <a:solidFill>
                      <a:srgbClr val="000000"/>
                    </a:solidFill>
                    <a:latin typeface="Arial Narrow"/>
                    <a:ea typeface="Arial"/>
                  </a:rPr>
                  <a:t>244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S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3" name="Rectangle 766"/>
              <p:cNvSpPr/>
              <p:nvPr/>
            </p:nvSpPr>
            <p:spPr>
              <a:xfrm rot="18360000">
                <a:off x="4684320" y="2237400"/>
                <a:ext cx="4734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G</a:t>
                </a:r>
                <a:r>
                  <a:rPr b="0" lang="en-US" sz="1200" spc="-1" strike="noStrike" baseline="30000">
                    <a:solidFill>
                      <a:srgbClr val="000000"/>
                    </a:solidFill>
                    <a:latin typeface="Arial Narrow"/>
                    <a:ea typeface="Arial"/>
                  </a:rPr>
                  <a:t>244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T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4" name="Rectangle 766"/>
              <p:cNvSpPr/>
              <p:nvPr/>
            </p:nvSpPr>
            <p:spPr>
              <a:xfrm rot="18360000">
                <a:off x="4998240" y="2231280"/>
                <a:ext cx="487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G</a:t>
                </a:r>
                <a:r>
                  <a:rPr b="0" lang="en-US" sz="1200" spc="-1" strike="noStrike" baseline="30000">
                    <a:solidFill>
                      <a:srgbClr val="000000"/>
                    </a:solidFill>
                    <a:latin typeface="Arial Narrow"/>
                    <a:ea typeface="Arial"/>
                  </a:rPr>
                  <a:t>244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N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5" name="Rectangle 766"/>
              <p:cNvSpPr/>
              <p:nvPr/>
            </p:nvSpPr>
            <p:spPr>
              <a:xfrm rot="18360000">
                <a:off x="5155200" y="2228400"/>
                <a:ext cx="494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G</a:t>
                </a:r>
                <a:r>
                  <a:rPr b="0" lang="en-US" sz="1200" spc="-1" strike="noStrike" baseline="30000">
                    <a:solidFill>
                      <a:srgbClr val="000000"/>
                    </a:solidFill>
                    <a:latin typeface="Arial Narrow"/>
                    <a:ea typeface="Arial"/>
                  </a:rPr>
                  <a:t>244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Q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66" name="Group 21"/>
            <p:cNvGrpSpPr/>
            <p:nvPr/>
          </p:nvGrpSpPr>
          <p:grpSpPr>
            <a:xfrm>
              <a:off x="3479760" y="3849840"/>
              <a:ext cx="2592360" cy="289080"/>
              <a:chOff x="3479760" y="3849840"/>
              <a:chExt cx="2592360" cy="289080"/>
            </a:xfrm>
          </p:grpSpPr>
          <p:grpSp>
            <p:nvGrpSpPr>
              <p:cNvPr id="67" name="Group 15"/>
              <p:cNvGrpSpPr/>
              <p:nvPr/>
            </p:nvGrpSpPr>
            <p:grpSpPr>
              <a:xfrm>
                <a:off x="3479760" y="3849840"/>
                <a:ext cx="2590560" cy="289080"/>
                <a:chOff x="3479760" y="3849840"/>
                <a:chExt cx="2590560" cy="289080"/>
              </a:xfrm>
            </p:grpSpPr>
            <p:pic>
              <p:nvPicPr>
                <p:cNvPr id="68" name="Picture 26" descr="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3479760" y="3849840"/>
                  <a:ext cx="1170000" cy="2890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69" name="Picture 27" descr=""/>
                <p:cNvPicPr/>
                <p:nvPr/>
              </p:nvPicPr>
              <p:blipFill>
                <a:blip r:embed="rId5">
                  <a:lum contrast="8000"/>
                </a:blip>
                <a:stretch/>
              </p:blipFill>
              <p:spPr>
                <a:xfrm>
                  <a:off x="4647240" y="3849840"/>
                  <a:ext cx="1423080" cy="28908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70" name="직사각형 426"/>
              <p:cNvSpPr/>
              <p:nvPr/>
            </p:nvSpPr>
            <p:spPr>
              <a:xfrm>
                <a:off x="3479760" y="3849840"/>
                <a:ext cx="2592360" cy="287280"/>
              </a:xfrm>
              <a:prstGeom prst="rect">
                <a:avLst/>
              </a:pr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71" name="Group 22"/>
            <p:cNvGrpSpPr/>
            <p:nvPr/>
          </p:nvGrpSpPr>
          <p:grpSpPr>
            <a:xfrm>
              <a:off x="3479760" y="4177440"/>
              <a:ext cx="2592720" cy="286920"/>
              <a:chOff x="3479760" y="4177440"/>
              <a:chExt cx="2592720" cy="286920"/>
            </a:xfrm>
          </p:grpSpPr>
          <p:grpSp>
            <p:nvGrpSpPr>
              <p:cNvPr id="72" name="Group 16"/>
              <p:cNvGrpSpPr/>
              <p:nvPr/>
            </p:nvGrpSpPr>
            <p:grpSpPr>
              <a:xfrm>
                <a:off x="3479760" y="4177440"/>
                <a:ext cx="2592720" cy="286920"/>
                <a:chOff x="3479760" y="4177440"/>
                <a:chExt cx="2592720" cy="286920"/>
              </a:xfrm>
            </p:grpSpPr>
            <p:pic>
              <p:nvPicPr>
                <p:cNvPr id="73" name="Picture 29" descr=""/>
                <p:cNvPicPr/>
                <p:nvPr/>
              </p:nvPicPr>
              <p:blipFill>
                <a:blip r:embed="rId6">
                  <a:lum contrast="10000"/>
                </a:blip>
                <a:stretch/>
              </p:blipFill>
              <p:spPr>
                <a:xfrm flipH="1">
                  <a:off x="4643280" y="4177440"/>
                  <a:ext cx="1429200" cy="2869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4" name="Picture 28" descr=""/>
                <p:cNvPicPr/>
                <p:nvPr/>
              </p:nvPicPr>
              <p:blipFill>
                <a:blip r:embed="rId7">
                  <a:lum contrast="10000"/>
                </a:blip>
                <a:stretch/>
              </p:blipFill>
              <p:spPr>
                <a:xfrm>
                  <a:off x="3479760" y="4177440"/>
                  <a:ext cx="1166760" cy="28692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75" name="직사각형 431"/>
              <p:cNvSpPr/>
              <p:nvPr/>
            </p:nvSpPr>
            <p:spPr>
              <a:xfrm>
                <a:off x="3479760" y="4178160"/>
                <a:ext cx="2592360" cy="285840"/>
              </a:xfrm>
              <a:prstGeom prst="rect">
                <a:avLst/>
              </a:pr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76" name="Group 23"/>
            <p:cNvGrpSpPr/>
            <p:nvPr/>
          </p:nvGrpSpPr>
          <p:grpSpPr>
            <a:xfrm>
              <a:off x="3479760" y="4503240"/>
              <a:ext cx="2592720" cy="240480"/>
              <a:chOff x="3479760" y="4503240"/>
              <a:chExt cx="2592720" cy="240480"/>
            </a:xfrm>
          </p:grpSpPr>
          <p:grpSp>
            <p:nvGrpSpPr>
              <p:cNvPr id="77" name="Group 17"/>
              <p:cNvGrpSpPr/>
              <p:nvPr/>
            </p:nvGrpSpPr>
            <p:grpSpPr>
              <a:xfrm>
                <a:off x="3479760" y="4503240"/>
                <a:ext cx="2592720" cy="240480"/>
                <a:chOff x="3479760" y="4503240"/>
                <a:chExt cx="2592720" cy="240480"/>
              </a:xfrm>
            </p:grpSpPr>
            <p:pic>
              <p:nvPicPr>
                <p:cNvPr id="78" name="Picture 32" descr=""/>
                <p:cNvPicPr/>
                <p:nvPr/>
              </p:nvPicPr>
              <p:blipFill>
                <a:blip r:embed="rId8">
                  <a:lum contrast="2000"/>
                </a:blip>
                <a:stretch/>
              </p:blipFill>
              <p:spPr>
                <a:xfrm>
                  <a:off x="4632840" y="4503240"/>
                  <a:ext cx="1439640" cy="2404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9" name="Picture 31" descr=""/>
                <p:cNvPicPr/>
                <p:nvPr/>
              </p:nvPicPr>
              <p:blipFill>
                <a:blip r:embed="rId9"/>
                <a:stretch/>
              </p:blipFill>
              <p:spPr>
                <a:xfrm>
                  <a:off x="3479760" y="4503240"/>
                  <a:ext cx="1157760" cy="24048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80" name="직사각형 436"/>
              <p:cNvSpPr/>
              <p:nvPr/>
            </p:nvSpPr>
            <p:spPr>
              <a:xfrm>
                <a:off x="3479760" y="4503600"/>
                <a:ext cx="2592360" cy="239760"/>
              </a:xfrm>
              <a:prstGeom prst="rect">
                <a:avLst/>
              </a:pr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81" name="Group 27"/>
            <p:cNvGrpSpPr/>
            <p:nvPr/>
          </p:nvGrpSpPr>
          <p:grpSpPr>
            <a:xfrm>
              <a:off x="6081480" y="2499480"/>
              <a:ext cx="550800" cy="2236680"/>
              <a:chOff x="6081480" y="2499480"/>
              <a:chExt cx="550800" cy="2236680"/>
            </a:xfrm>
          </p:grpSpPr>
          <p:sp>
            <p:nvSpPr>
              <p:cNvPr id="82" name="TextBox 39"/>
              <p:cNvSpPr/>
              <p:nvPr/>
            </p:nvSpPr>
            <p:spPr>
              <a:xfrm flipH="1">
                <a:off x="6081840" y="2499480"/>
                <a:ext cx="381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NS5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83" name="Line 750"/>
              <p:cNvSpPr/>
              <p:nvPr/>
            </p:nvSpPr>
            <p:spPr>
              <a:xfrm flipH="1">
                <a:off x="6083640" y="2625840"/>
                <a:ext cx="66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84" name="TextBox 42"/>
              <p:cNvSpPr/>
              <p:nvPr/>
            </p:nvSpPr>
            <p:spPr>
              <a:xfrm flipH="1">
                <a:off x="6081840" y="2657880"/>
                <a:ext cx="381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NS3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85" name="Line 750"/>
              <p:cNvSpPr/>
              <p:nvPr/>
            </p:nvSpPr>
            <p:spPr>
              <a:xfrm flipH="1">
                <a:off x="6083640" y="2785320"/>
                <a:ext cx="66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86" name="TextBox 48"/>
              <p:cNvSpPr/>
              <p:nvPr/>
            </p:nvSpPr>
            <p:spPr>
              <a:xfrm flipH="1">
                <a:off x="6081480" y="2776320"/>
                <a:ext cx="249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E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cxnSp>
            <p:nvCxnSpPr>
              <p:cNvPr id="87" name="꺾인 연결선 346"/>
              <p:cNvCxnSpPr/>
              <p:nvPr/>
            </p:nvCxnSpPr>
            <p:spPr>
              <a:xfrm flipV="1" rot="10800000">
                <a:off x="6082560" y="2901600"/>
                <a:ext cx="67320" cy="49680"/>
              </a:xfrm>
              <a:prstGeom prst="bentConnector3">
                <a:avLst>
                  <a:gd name="adj1" fmla="val 50000"/>
                </a:avLst>
              </a:prstGeom>
              <a:ln w="9360">
                <a:solidFill>
                  <a:srgbClr val="000000"/>
                </a:solidFill>
                <a:miter/>
              </a:ln>
            </p:spPr>
          </p:cxnSp>
          <p:sp>
            <p:nvSpPr>
              <p:cNvPr id="88" name="TextBox 45"/>
              <p:cNvSpPr/>
              <p:nvPr/>
            </p:nvSpPr>
            <p:spPr>
              <a:xfrm flipH="1">
                <a:off x="6081840" y="2938680"/>
                <a:ext cx="381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NS1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cxnSp>
            <p:nvCxnSpPr>
              <p:cNvPr id="89" name="꺾인 연결선 344"/>
              <p:cNvCxnSpPr/>
              <p:nvPr/>
            </p:nvCxnSpPr>
            <p:spPr>
              <a:xfrm rot="10800000">
                <a:off x="6082560" y="3010680"/>
                <a:ext cx="67320" cy="49680"/>
              </a:xfrm>
              <a:prstGeom prst="bentConnector3">
                <a:avLst>
                  <a:gd name="adj1" fmla="val 50000"/>
                </a:avLst>
              </a:prstGeom>
              <a:ln w="9360">
                <a:solidFill>
                  <a:srgbClr val="000000"/>
                </a:solidFill>
                <a:miter/>
              </a:ln>
            </p:spPr>
          </p:cxnSp>
          <p:sp>
            <p:nvSpPr>
              <p:cNvPr id="90" name="TextBox 101"/>
              <p:cNvSpPr/>
              <p:nvPr/>
            </p:nvSpPr>
            <p:spPr>
              <a:xfrm flipH="1">
                <a:off x="6081120" y="3212280"/>
                <a:ext cx="255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C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1" name="Line 750"/>
              <p:cNvSpPr/>
              <p:nvPr/>
            </p:nvSpPr>
            <p:spPr>
              <a:xfrm flipH="1">
                <a:off x="6084000" y="3336840"/>
                <a:ext cx="66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2" name="TextBox 82"/>
              <p:cNvSpPr/>
              <p:nvPr/>
            </p:nvSpPr>
            <p:spPr>
              <a:xfrm flipH="1">
                <a:off x="6081480" y="3871440"/>
                <a:ext cx="249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E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3" name="Line 750"/>
              <p:cNvSpPr/>
              <p:nvPr/>
            </p:nvSpPr>
            <p:spPr>
              <a:xfrm flipH="1">
                <a:off x="6084000" y="3996000"/>
                <a:ext cx="66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4" name="TextBox 91"/>
              <p:cNvSpPr/>
              <p:nvPr/>
            </p:nvSpPr>
            <p:spPr>
              <a:xfrm flipH="1">
                <a:off x="6081840" y="4137480"/>
                <a:ext cx="381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NS1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5" name="Line 750"/>
              <p:cNvSpPr/>
              <p:nvPr/>
            </p:nvSpPr>
            <p:spPr>
              <a:xfrm flipH="1">
                <a:off x="6084000" y="4263120"/>
                <a:ext cx="66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6" name="TextBox 96"/>
              <p:cNvSpPr/>
              <p:nvPr/>
            </p:nvSpPr>
            <p:spPr>
              <a:xfrm flipH="1">
                <a:off x="6084360" y="4489920"/>
                <a:ext cx="547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GAPDH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7" name="Line 750"/>
              <p:cNvSpPr/>
              <p:nvPr/>
            </p:nvSpPr>
            <p:spPr>
              <a:xfrm flipH="1">
                <a:off x="6083640" y="4611240"/>
                <a:ext cx="66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8" name="TextBox 107"/>
              <p:cNvSpPr/>
              <p:nvPr/>
            </p:nvSpPr>
            <p:spPr>
              <a:xfrm flipH="1">
                <a:off x="6081840" y="3551760"/>
                <a:ext cx="360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prM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9" name="Line 750"/>
              <p:cNvSpPr/>
              <p:nvPr/>
            </p:nvSpPr>
            <p:spPr>
              <a:xfrm flipH="1">
                <a:off x="6084000" y="3675960"/>
                <a:ext cx="66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100" name="Group 20"/>
            <p:cNvGrpSpPr/>
            <p:nvPr/>
          </p:nvGrpSpPr>
          <p:grpSpPr>
            <a:xfrm>
              <a:off x="3479760" y="3524400"/>
              <a:ext cx="2592360" cy="286920"/>
              <a:chOff x="3479760" y="3524400"/>
              <a:chExt cx="2592360" cy="286920"/>
            </a:xfrm>
          </p:grpSpPr>
          <p:grpSp>
            <p:nvGrpSpPr>
              <p:cNvPr id="101" name="Group 14"/>
              <p:cNvGrpSpPr/>
              <p:nvPr/>
            </p:nvGrpSpPr>
            <p:grpSpPr>
              <a:xfrm>
                <a:off x="3479760" y="3524400"/>
                <a:ext cx="2590560" cy="286920"/>
                <a:chOff x="3479760" y="3524400"/>
                <a:chExt cx="2590560" cy="286920"/>
              </a:xfrm>
            </p:grpSpPr>
            <p:pic>
              <p:nvPicPr>
                <p:cNvPr id="102" name="Picture 36" descr=""/>
                <p:cNvPicPr/>
                <p:nvPr/>
              </p:nvPicPr>
              <p:blipFill>
                <a:blip r:embed="rId10">
                  <a:lum contrast="-4000"/>
                </a:blip>
                <a:stretch/>
              </p:blipFill>
              <p:spPr>
                <a:xfrm flipH="1">
                  <a:off x="4621680" y="3524400"/>
                  <a:ext cx="1448640" cy="2869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03" name="Picture 35" descr=""/>
                <p:cNvPicPr/>
                <p:nvPr/>
              </p:nvPicPr>
              <p:blipFill>
                <a:blip r:embed="rId11">
                  <a:lum contrast="-16000"/>
                </a:blip>
                <a:stretch/>
              </p:blipFill>
              <p:spPr>
                <a:xfrm>
                  <a:off x="3479760" y="3524400"/>
                  <a:ext cx="1143720" cy="28692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104" name="직사각형 441"/>
              <p:cNvSpPr/>
              <p:nvPr/>
            </p:nvSpPr>
            <p:spPr>
              <a:xfrm>
                <a:off x="3479760" y="3524400"/>
                <a:ext cx="2592360" cy="286920"/>
              </a:xfrm>
              <a:prstGeom prst="rect">
                <a:avLst/>
              </a:pr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sp>
          <p:nvSpPr>
            <p:cNvPr id="105" name="TextBox 46"/>
            <p:cNvSpPr/>
            <p:nvPr/>
          </p:nvSpPr>
          <p:spPr>
            <a:xfrm>
              <a:off x="2568240" y="2707200"/>
              <a:ext cx="548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  <a:ea typeface="Arial"/>
                </a:rPr>
                <a:t>-JEV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6" name="TextBox 46"/>
            <p:cNvSpPr/>
            <p:nvPr/>
          </p:nvSpPr>
          <p:spPr>
            <a:xfrm>
              <a:off x="2709000" y="3201480"/>
              <a:ext cx="407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  <a:ea typeface="Arial"/>
                </a:rPr>
                <a:t>-C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7" name="직선 연결선 17"/>
            <p:cNvSpPr/>
            <p:nvPr/>
          </p:nvSpPr>
          <p:spPr>
            <a:xfrm>
              <a:off x="3070080" y="3193920"/>
              <a:ext cx="0" cy="2919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8" name="TextBox 46"/>
            <p:cNvSpPr/>
            <p:nvPr/>
          </p:nvSpPr>
          <p:spPr>
            <a:xfrm>
              <a:off x="2715480" y="3853800"/>
              <a:ext cx="401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  <a:ea typeface="Arial"/>
                </a:rPr>
                <a:t>-E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9" name="직선 연결선 394"/>
            <p:cNvSpPr/>
            <p:nvPr/>
          </p:nvSpPr>
          <p:spPr>
            <a:xfrm>
              <a:off x="3070080" y="3848040"/>
              <a:ext cx="0" cy="2934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0" name="TextBox 46"/>
            <p:cNvSpPr/>
            <p:nvPr/>
          </p:nvSpPr>
          <p:spPr>
            <a:xfrm>
              <a:off x="2554200" y="4182840"/>
              <a:ext cx="561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  <a:ea typeface="Arial"/>
                </a:rPr>
                <a:t>-NS1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1" name="직선 연결선 395"/>
            <p:cNvSpPr/>
            <p:nvPr/>
          </p:nvSpPr>
          <p:spPr>
            <a:xfrm>
              <a:off x="3070080" y="4178520"/>
              <a:ext cx="0" cy="2872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2" name="TextBox 46"/>
            <p:cNvSpPr/>
            <p:nvPr/>
          </p:nvSpPr>
          <p:spPr>
            <a:xfrm>
              <a:off x="2352240" y="4485600"/>
              <a:ext cx="762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  <a:ea typeface="Arial"/>
                </a:rPr>
                <a:t>-GAPDH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3" name="직선 연결선 396"/>
            <p:cNvSpPr/>
            <p:nvPr/>
          </p:nvSpPr>
          <p:spPr>
            <a:xfrm>
              <a:off x="3070080" y="4503960"/>
              <a:ext cx="0" cy="2394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4" name="TextBox 46"/>
            <p:cNvSpPr/>
            <p:nvPr/>
          </p:nvSpPr>
          <p:spPr>
            <a:xfrm>
              <a:off x="2687760" y="3528000"/>
              <a:ext cx="429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  <a:ea typeface="Arial"/>
                </a:rPr>
                <a:t>-pr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5" name="직선 연결선 18"/>
            <p:cNvSpPr/>
            <p:nvPr/>
          </p:nvSpPr>
          <p:spPr>
            <a:xfrm>
              <a:off x="3070080" y="3524040"/>
              <a:ext cx="0" cy="2854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grpSp>
          <p:nvGrpSpPr>
            <p:cNvPr id="116" name="Group 28"/>
            <p:cNvGrpSpPr/>
            <p:nvPr/>
          </p:nvGrpSpPr>
          <p:grpSpPr>
            <a:xfrm>
              <a:off x="3099240" y="2232000"/>
              <a:ext cx="365040" cy="2441880"/>
              <a:chOff x="3099240" y="2232000"/>
              <a:chExt cx="365040" cy="2441880"/>
            </a:xfrm>
          </p:grpSpPr>
          <p:sp>
            <p:nvSpPr>
              <p:cNvPr id="117" name="TextBox 50"/>
              <p:cNvSpPr/>
              <p:nvPr/>
            </p:nvSpPr>
            <p:spPr>
              <a:xfrm>
                <a:off x="3099240" y="2232000"/>
                <a:ext cx="365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kDa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18" name="TextBox 30"/>
              <p:cNvSpPr/>
              <p:nvPr/>
            </p:nvSpPr>
            <p:spPr>
              <a:xfrm>
                <a:off x="3167280" y="268488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66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19" name="Line 750"/>
              <p:cNvSpPr/>
              <p:nvPr/>
            </p:nvSpPr>
            <p:spPr>
              <a:xfrm>
                <a:off x="3396240" y="2808360"/>
                <a:ext cx="66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20" name="TextBox 58"/>
              <p:cNvSpPr/>
              <p:nvPr/>
            </p:nvSpPr>
            <p:spPr>
              <a:xfrm>
                <a:off x="3109320" y="2418480"/>
                <a:ext cx="354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220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21" name="Line 750"/>
              <p:cNvSpPr/>
              <p:nvPr/>
            </p:nvSpPr>
            <p:spPr>
              <a:xfrm>
                <a:off x="3395880" y="2541960"/>
                <a:ext cx="66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22" name="TextBox 27"/>
              <p:cNvSpPr/>
              <p:nvPr/>
            </p:nvSpPr>
            <p:spPr>
              <a:xfrm>
                <a:off x="3167280" y="255168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97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23" name="Line 750"/>
              <p:cNvSpPr/>
              <p:nvPr/>
            </p:nvSpPr>
            <p:spPr>
              <a:xfrm>
                <a:off x="3396240" y="2675160"/>
                <a:ext cx="66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24" name="TextBox 33"/>
              <p:cNvSpPr/>
              <p:nvPr/>
            </p:nvSpPr>
            <p:spPr>
              <a:xfrm>
                <a:off x="3167280" y="315396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14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25" name="Line 750"/>
              <p:cNvSpPr/>
              <p:nvPr/>
            </p:nvSpPr>
            <p:spPr>
              <a:xfrm>
                <a:off x="3396240" y="3276360"/>
                <a:ext cx="66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26" name="TextBox 33"/>
              <p:cNvSpPr/>
              <p:nvPr/>
            </p:nvSpPr>
            <p:spPr>
              <a:xfrm>
                <a:off x="3167280" y="395028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45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27" name="Line 750"/>
              <p:cNvSpPr/>
              <p:nvPr/>
            </p:nvSpPr>
            <p:spPr>
              <a:xfrm>
                <a:off x="3396240" y="4073760"/>
                <a:ext cx="66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28" name="TextBox 33"/>
              <p:cNvSpPr/>
              <p:nvPr/>
            </p:nvSpPr>
            <p:spPr>
              <a:xfrm>
                <a:off x="3167280" y="414252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45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29" name="Line 750"/>
              <p:cNvSpPr/>
              <p:nvPr/>
            </p:nvSpPr>
            <p:spPr>
              <a:xfrm>
                <a:off x="3396240" y="4266000"/>
                <a:ext cx="66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30" name="TextBox 33"/>
              <p:cNvSpPr/>
              <p:nvPr/>
            </p:nvSpPr>
            <p:spPr>
              <a:xfrm>
                <a:off x="3167280" y="442764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45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31" name="Line 750"/>
              <p:cNvSpPr/>
              <p:nvPr/>
            </p:nvSpPr>
            <p:spPr>
              <a:xfrm>
                <a:off x="3396240" y="4551120"/>
                <a:ext cx="66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32" name="TextBox 33"/>
              <p:cNvSpPr/>
              <p:nvPr/>
            </p:nvSpPr>
            <p:spPr>
              <a:xfrm>
                <a:off x="3167280" y="363960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20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33" name="Line 750"/>
              <p:cNvSpPr/>
              <p:nvPr/>
            </p:nvSpPr>
            <p:spPr>
              <a:xfrm>
                <a:off x="3396240" y="3763080"/>
                <a:ext cx="66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34" name="TextBox 33"/>
              <p:cNvSpPr/>
              <p:nvPr/>
            </p:nvSpPr>
            <p:spPr>
              <a:xfrm>
                <a:off x="3167280" y="344736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30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35" name="Line 750"/>
              <p:cNvSpPr/>
              <p:nvPr/>
            </p:nvSpPr>
            <p:spPr>
              <a:xfrm>
                <a:off x="3396240" y="3570840"/>
                <a:ext cx="66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36" name="TextBox 33"/>
              <p:cNvSpPr/>
              <p:nvPr/>
            </p:nvSpPr>
            <p:spPr>
              <a:xfrm>
                <a:off x="3167280" y="288432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Arial"/>
                  </a:rPr>
                  <a:t>45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37" name="Line 750"/>
              <p:cNvSpPr/>
              <p:nvPr/>
            </p:nvSpPr>
            <p:spPr>
              <a:xfrm>
                <a:off x="3396240" y="3007800"/>
                <a:ext cx="66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sp>
          <p:nvSpPr>
            <p:cNvPr id="138" name="직선 연결선 16"/>
            <p:cNvSpPr/>
            <p:nvPr/>
          </p:nvSpPr>
          <p:spPr>
            <a:xfrm>
              <a:off x="3070080" y="2535120"/>
              <a:ext cx="0" cy="6220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grpSp>
          <p:nvGrpSpPr>
            <p:cNvPr id="139" name="Group 18"/>
            <p:cNvGrpSpPr/>
            <p:nvPr/>
          </p:nvGrpSpPr>
          <p:grpSpPr>
            <a:xfrm>
              <a:off x="3479760" y="2534760"/>
              <a:ext cx="2592360" cy="622440"/>
              <a:chOff x="3479760" y="2534760"/>
              <a:chExt cx="2592360" cy="622440"/>
            </a:xfrm>
          </p:grpSpPr>
          <p:grpSp>
            <p:nvGrpSpPr>
              <p:cNvPr id="140" name="Group 12"/>
              <p:cNvGrpSpPr/>
              <p:nvPr/>
            </p:nvGrpSpPr>
            <p:grpSpPr>
              <a:xfrm>
                <a:off x="3479760" y="2534760"/>
                <a:ext cx="2592360" cy="621360"/>
                <a:chOff x="3479760" y="2534760"/>
                <a:chExt cx="2592360" cy="621360"/>
              </a:xfrm>
            </p:grpSpPr>
            <p:pic>
              <p:nvPicPr>
                <p:cNvPr id="141" name="Picture 34" descr=""/>
                <p:cNvPicPr/>
                <p:nvPr/>
              </p:nvPicPr>
              <p:blipFill>
                <a:blip r:embed="rId12"/>
                <a:stretch/>
              </p:blipFill>
              <p:spPr>
                <a:xfrm flipH="1">
                  <a:off x="4637520" y="2534760"/>
                  <a:ext cx="1434600" cy="6213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42" name="Picture 33" descr=""/>
                <p:cNvPicPr/>
                <p:nvPr/>
              </p:nvPicPr>
              <p:blipFill>
                <a:blip r:embed="rId13"/>
                <a:stretch/>
              </p:blipFill>
              <p:spPr>
                <a:xfrm>
                  <a:off x="3479760" y="2534760"/>
                  <a:ext cx="1162440" cy="62136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143" name="직사각형 423"/>
              <p:cNvSpPr/>
              <p:nvPr/>
            </p:nvSpPr>
            <p:spPr>
              <a:xfrm>
                <a:off x="3479760" y="2535120"/>
                <a:ext cx="2592360" cy="622080"/>
              </a:xfrm>
              <a:prstGeom prst="rect">
                <a:avLst/>
              </a:pr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5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7-05T16:33:49Z</dcterms:created>
  <dc:creator>Youngmin Lee</dc:creator>
  <dc:description/>
  <dc:language>en-US</dc:language>
  <cp:lastModifiedBy>Young-Min Lee</cp:lastModifiedBy>
  <dcterms:modified xsi:type="dcterms:W3CDTF">2014-01-29T22:35:07Z</dcterms:modified>
  <cp:revision>219</cp:revision>
  <dc:subject/>
  <dc:title>PowerPoint 프레젠테이션</dc:title>
</cp:coreProperties>
</file>